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96" r:id="rId2"/>
    <p:sldId id="297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2" autoAdjust="0"/>
    <p:restoredTop sz="92374" autoAdjust="0"/>
  </p:normalViewPr>
  <p:slideViewPr>
    <p:cSldViewPr>
      <p:cViewPr>
        <p:scale>
          <a:sx n="120" d="100"/>
          <a:sy n="120" d="100"/>
        </p:scale>
        <p:origin x="-1638" y="30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lupo\Desktop\STANKYRASE\Additional%20File%2010_Fig.S4_Raw%20data_DIAMONDD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lupo\Desktop\STANKYRASE\Additional%20File%2010_Fig.S4_Raw%20data_DIAMONDD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lupo\Desktop\STANKYRASE\Additional%20File%2010_Fig.S4_Raw%20data_DIAMONDD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lupo\Desktop\STANKYRASE\Additional%20File%2010_Fig.S4_Raw%20data_DIAMONDD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lupo\Desktop\STANKYRASE\Additional%20File%2010_Fig.S4_Raw%20data_DIAMONDD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lupo\Desktop\STANKYRASE\Additional%20File%2010_Fig.S4_Raw%20data_DIAMONDD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4SB_Average (paper)'!$S$22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22:$BL$22</c:f>
              <c:numCache>
                <c:formatCode>General</c:formatCode>
                <c:ptCount val="45"/>
                <c:pt idx="1">
                  <c:v>4.4156113333333309</c:v>
                </c:pt>
                <c:pt idx="4">
                  <c:v>7.7048290000000001</c:v>
                </c:pt>
                <c:pt idx="7">
                  <c:v>0.12532799999999611</c:v>
                </c:pt>
                <c:pt idx="10">
                  <c:v>-8.7731333333337602E-2</c:v>
                </c:pt>
                <c:pt idx="13">
                  <c:v>3.9896069999999959</c:v>
                </c:pt>
                <c:pt idx="16">
                  <c:v>3.6602033333333353</c:v>
                </c:pt>
                <c:pt idx="19">
                  <c:v>6.0218350000000029</c:v>
                </c:pt>
                <c:pt idx="22">
                  <c:v>1.3409666666667874E-2</c:v>
                </c:pt>
                <c:pt idx="25">
                  <c:v>-0.29188399999999959</c:v>
                </c:pt>
                <c:pt idx="28">
                  <c:v>1.7679399999999958</c:v>
                </c:pt>
                <c:pt idx="31">
                  <c:v>4.3736516666666674</c:v>
                </c:pt>
                <c:pt idx="34">
                  <c:v>8.736143000000002</c:v>
                </c:pt>
                <c:pt idx="37">
                  <c:v>0.32072799999999546</c:v>
                </c:pt>
                <c:pt idx="40">
                  <c:v>-0.17155133333333339</c:v>
                </c:pt>
                <c:pt idx="43">
                  <c:v>3.411642333333329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4SB_Average (paper)'!$S$23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  <c:spPr>
              <a:ln w="28575"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23:$BL$23</c:f>
              <c:numCache>
                <c:formatCode>General</c:formatCode>
                <c:ptCount val="45"/>
                <c:pt idx="1">
                  <c:v>4.3846480000000021</c:v>
                </c:pt>
                <c:pt idx="4">
                  <c:v>5.5069820000000043</c:v>
                </c:pt>
                <c:pt idx="7">
                  <c:v>0.11095400000000311</c:v>
                </c:pt>
                <c:pt idx="10">
                  <c:v>9.1752999999997087E-2</c:v>
                </c:pt>
                <c:pt idx="13">
                  <c:v>2.351020666666674</c:v>
                </c:pt>
                <c:pt idx="16">
                  <c:v>3.2906781666666696</c:v>
                </c:pt>
                <c:pt idx="19">
                  <c:v>4.877813833333331</c:v>
                </c:pt>
                <c:pt idx="22">
                  <c:v>-8.0964500000000328E-2</c:v>
                </c:pt>
                <c:pt idx="25">
                  <c:v>2.4180833333328877E-2</c:v>
                </c:pt>
                <c:pt idx="28">
                  <c:v>1.0914915000000001</c:v>
                </c:pt>
                <c:pt idx="31">
                  <c:v>4.4476264999999984</c:v>
                </c:pt>
                <c:pt idx="34">
                  <c:v>6.7176898333333277</c:v>
                </c:pt>
                <c:pt idx="37">
                  <c:v>-2.4062500000002984E-2</c:v>
                </c:pt>
                <c:pt idx="40">
                  <c:v>-4.1805000000003645E-3</c:v>
                </c:pt>
                <c:pt idx="43">
                  <c:v>2.2957605000000036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4SB_Average (paper)'!$S$24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dPt>
            <c:idx val="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5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7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8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FF0000"/>
                </a:solidFill>
              </a:ln>
            </c:spPr>
          </c:dPt>
          <c:dPt>
            <c:idx val="2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21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3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4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6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7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9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24:$BL$24</c:f>
              <c:numCache>
                <c:formatCode>General</c:formatCode>
                <c:ptCount val="45"/>
                <c:pt idx="0">
                  <c:v>4.4001296666666665</c:v>
                </c:pt>
                <c:pt idx="1">
                  <c:v>4.4001296666666665</c:v>
                </c:pt>
                <c:pt idx="2">
                  <c:v>4.4001296666666665</c:v>
                </c:pt>
                <c:pt idx="3">
                  <c:v>6.6059055000000022</c:v>
                </c:pt>
                <c:pt idx="4">
                  <c:v>6.6059055000000022</c:v>
                </c:pt>
                <c:pt idx="5">
                  <c:v>6.6059055000000022</c:v>
                </c:pt>
                <c:pt idx="6">
                  <c:v>0.11814099999999961</c:v>
                </c:pt>
                <c:pt idx="7">
                  <c:v>0.11814099999999961</c:v>
                </c:pt>
                <c:pt idx="8">
                  <c:v>0.11814099999999961</c:v>
                </c:pt>
                <c:pt idx="9">
                  <c:v>2.0108333333297423E-3</c:v>
                </c:pt>
                <c:pt idx="10">
                  <c:v>2.0108333333297423E-3</c:v>
                </c:pt>
                <c:pt idx="11">
                  <c:v>2.0108333333297423E-3</c:v>
                </c:pt>
                <c:pt idx="12">
                  <c:v>3.1703138333333349</c:v>
                </c:pt>
                <c:pt idx="13">
                  <c:v>3.1703138333333349</c:v>
                </c:pt>
                <c:pt idx="14">
                  <c:v>3.1703138333333349</c:v>
                </c:pt>
                <c:pt idx="15">
                  <c:v>3.4754407500000024</c:v>
                </c:pt>
                <c:pt idx="16">
                  <c:v>3.4754407500000024</c:v>
                </c:pt>
                <c:pt idx="17">
                  <c:v>3.4754407500000024</c:v>
                </c:pt>
                <c:pt idx="18">
                  <c:v>5.4498244166666669</c:v>
                </c:pt>
                <c:pt idx="19">
                  <c:v>5.4498244166666669</c:v>
                </c:pt>
                <c:pt idx="20">
                  <c:v>5.4498244166666669</c:v>
                </c:pt>
                <c:pt idx="21">
                  <c:v>-3.3777416666666227E-2</c:v>
                </c:pt>
                <c:pt idx="22">
                  <c:v>-3.3777416666666227E-2</c:v>
                </c:pt>
                <c:pt idx="23">
                  <c:v>-3.3777416666666227E-2</c:v>
                </c:pt>
                <c:pt idx="24">
                  <c:v>-0.13385158333333536</c:v>
                </c:pt>
                <c:pt idx="25">
                  <c:v>-0.13385158333333536</c:v>
                </c:pt>
                <c:pt idx="26">
                  <c:v>-0.13385158333333536</c:v>
                </c:pt>
                <c:pt idx="27">
                  <c:v>1.429715749999998</c:v>
                </c:pt>
                <c:pt idx="28">
                  <c:v>1.429715749999998</c:v>
                </c:pt>
                <c:pt idx="29">
                  <c:v>1.429715749999998</c:v>
                </c:pt>
                <c:pt idx="30">
                  <c:v>4.4106390833333329</c:v>
                </c:pt>
                <c:pt idx="31">
                  <c:v>4.4106390833333329</c:v>
                </c:pt>
                <c:pt idx="32">
                  <c:v>4.4106390833333329</c:v>
                </c:pt>
                <c:pt idx="33">
                  <c:v>7.7269164166666648</c:v>
                </c:pt>
                <c:pt idx="34">
                  <c:v>7.7269164166666648</c:v>
                </c:pt>
                <c:pt idx="35">
                  <c:v>7.7269164166666648</c:v>
                </c:pt>
                <c:pt idx="36">
                  <c:v>0.14833274999999624</c:v>
                </c:pt>
                <c:pt idx="37">
                  <c:v>0.14833274999999624</c:v>
                </c:pt>
                <c:pt idx="38">
                  <c:v>0.14833274999999624</c:v>
                </c:pt>
                <c:pt idx="39">
                  <c:v>-8.7865916666666877E-2</c:v>
                </c:pt>
                <c:pt idx="40">
                  <c:v>-8.7865916666666877E-2</c:v>
                </c:pt>
                <c:pt idx="41">
                  <c:v>-8.7865916666666877E-2</c:v>
                </c:pt>
                <c:pt idx="42">
                  <c:v>2.8537014166666665</c:v>
                </c:pt>
                <c:pt idx="43">
                  <c:v>2.8537014166666665</c:v>
                </c:pt>
                <c:pt idx="44">
                  <c:v>2.85370141666666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213056"/>
        <c:axId val="37167680"/>
      </c:scatterChart>
      <c:valAx>
        <c:axId val="83213056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crossAx val="37167680"/>
        <c:crosses val="autoZero"/>
        <c:crossBetween val="midCat"/>
        <c:majorUnit val="5"/>
      </c:valAx>
      <c:valAx>
        <c:axId val="37167680"/>
        <c:scaling>
          <c:orientation val="minMax"/>
          <c:min val="-1"/>
        </c:scaling>
        <c:delete val="0"/>
        <c:axPos val="l"/>
        <c:numFmt formatCode="General" sourceLinked="1"/>
        <c:majorTickMark val="out"/>
        <c:minorTickMark val="none"/>
        <c:tickLblPos val="nextTo"/>
        <c:crossAx val="83213056"/>
        <c:crosses val="autoZero"/>
        <c:crossBetween val="midCat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4SB_Average (paper)'!$S$30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30:$BL$30</c:f>
              <c:numCache>
                <c:formatCode>General</c:formatCode>
                <c:ptCount val="45"/>
                <c:pt idx="1">
                  <c:v>4.1537265000000048</c:v>
                </c:pt>
                <c:pt idx="4">
                  <c:v>0.15742050000000418</c:v>
                </c:pt>
                <c:pt idx="7">
                  <c:v>-0.91432083333333125</c:v>
                </c:pt>
                <c:pt idx="10">
                  <c:v>-3.2463166666662602E-2</c:v>
                </c:pt>
                <c:pt idx="13">
                  <c:v>0.12720616666667084</c:v>
                </c:pt>
                <c:pt idx="16">
                  <c:v>4.7625583333333346</c:v>
                </c:pt>
                <c:pt idx="19">
                  <c:v>-0.83485399999999998</c:v>
                </c:pt>
                <c:pt idx="22">
                  <c:v>-0.36188533333333694</c:v>
                </c:pt>
                <c:pt idx="25">
                  <c:v>0.5199723333333317</c:v>
                </c:pt>
                <c:pt idx="28">
                  <c:v>-3.0301000000005018E-2</c:v>
                </c:pt>
                <c:pt idx="31">
                  <c:v>3.0783086666666719</c:v>
                </c:pt>
                <c:pt idx="34">
                  <c:v>-0.43139466666666237</c:v>
                </c:pt>
                <c:pt idx="37">
                  <c:v>-0.58034500000000122</c:v>
                </c:pt>
                <c:pt idx="40">
                  <c:v>1.7680793333333398</c:v>
                </c:pt>
                <c:pt idx="43">
                  <c:v>0.1051530000000013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4SB_Average (paper)'!$S$31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  <c:spPr>
              <a:ln w="28575"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31:$BL$31</c:f>
              <c:numCache>
                <c:formatCode>General</c:formatCode>
                <c:ptCount val="45"/>
                <c:pt idx="1">
                  <c:v>3.8882543333333111</c:v>
                </c:pt>
                <c:pt idx="4">
                  <c:v>1.076505666666673</c:v>
                </c:pt>
                <c:pt idx="7">
                  <c:v>-6.2903333333359512E-3</c:v>
                </c:pt>
                <c:pt idx="10">
                  <c:v>1.9009333333336542E-2</c:v>
                </c:pt>
                <c:pt idx="13">
                  <c:v>-0.22634566666666345</c:v>
                </c:pt>
                <c:pt idx="16">
                  <c:v>3.8130156666666331</c:v>
                </c:pt>
                <c:pt idx="19">
                  <c:v>0.38951700000000145</c:v>
                </c:pt>
                <c:pt idx="22">
                  <c:v>-0.22122400000000297</c:v>
                </c:pt>
                <c:pt idx="25">
                  <c:v>-0.50958200000000176</c:v>
                </c:pt>
                <c:pt idx="28">
                  <c:v>-0.8003773333333335</c:v>
                </c:pt>
                <c:pt idx="31">
                  <c:v>4.2340153333332964</c:v>
                </c:pt>
                <c:pt idx="34">
                  <c:v>0.98801166666666518</c:v>
                </c:pt>
                <c:pt idx="37">
                  <c:v>-0.18017566666667051</c:v>
                </c:pt>
                <c:pt idx="40">
                  <c:v>-0.76847000000000065</c:v>
                </c:pt>
                <c:pt idx="43">
                  <c:v>0.656525999999999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4SB_Average (paper)'!$S$32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dPt>
            <c:idx val="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5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7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8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FF0000"/>
                </a:solidFill>
              </a:ln>
            </c:spPr>
          </c:dPt>
          <c:dPt>
            <c:idx val="2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21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3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4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6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7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9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32:$BL$32</c:f>
              <c:numCache>
                <c:formatCode>General</c:formatCode>
                <c:ptCount val="45"/>
                <c:pt idx="0">
                  <c:v>4.0209904166666579</c:v>
                </c:pt>
                <c:pt idx="1">
                  <c:v>4.0209904166666579</c:v>
                </c:pt>
                <c:pt idx="2">
                  <c:v>4.0209904166666579</c:v>
                </c:pt>
                <c:pt idx="3">
                  <c:v>0.6169630833333386</c:v>
                </c:pt>
                <c:pt idx="4">
                  <c:v>0.6169630833333386</c:v>
                </c:pt>
                <c:pt idx="5">
                  <c:v>0.6169630833333386</c:v>
                </c:pt>
                <c:pt idx="6">
                  <c:v>-0.4603055833333336</c:v>
                </c:pt>
                <c:pt idx="7">
                  <c:v>-0.4603055833333336</c:v>
                </c:pt>
                <c:pt idx="8">
                  <c:v>-0.4603055833333336</c:v>
                </c:pt>
                <c:pt idx="9">
                  <c:v>-6.7269166666630298E-3</c:v>
                </c:pt>
                <c:pt idx="10">
                  <c:v>-6.7269166666630298E-3</c:v>
                </c:pt>
                <c:pt idx="11">
                  <c:v>-6.7269166666630298E-3</c:v>
                </c:pt>
                <c:pt idx="12">
                  <c:v>-4.9569749999996304E-2</c:v>
                </c:pt>
                <c:pt idx="13">
                  <c:v>-4.9569749999996304E-2</c:v>
                </c:pt>
                <c:pt idx="14">
                  <c:v>-4.9569749999996304E-2</c:v>
                </c:pt>
                <c:pt idx="15">
                  <c:v>4.2877869999999838</c:v>
                </c:pt>
                <c:pt idx="16">
                  <c:v>4.2877869999999838</c:v>
                </c:pt>
                <c:pt idx="17">
                  <c:v>4.2877869999999838</c:v>
                </c:pt>
                <c:pt idx="18">
                  <c:v>-0.22266849999999927</c:v>
                </c:pt>
                <c:pt idx="19">
                  <c:v>-0.22266849999999927</c:v>
                </c:pt>
                <c:pt idx="20">
                  <c:v>-0.22266849999999927</c:v>
                </c:pt>
                <c:pt idx="21">
                  <c:v>-0.29155466666666996</c:v>
                </c:pt>
                <c:pt idx="22">
                  <c:v>-0.29155466666666996</c:v>
                </c:pt>
                <c:pt idx="23">
                  <c:v>-0.29155466666666996</c:v>
                </c:pt>
                <c:pt idx="24">
                  <c:v>5.1951666666649743E-3</c:v>
                </c:pt>
                <c:pt idx="25">
                  <c:v>5.1951666666649743E-3</c:v>
                </c:pt>
                <c:pt idx="26">
                  <c:v>5.1951666666649743E-3</c:v>
                </c:pt>
                <c:pt idx="27">
                  <c:v>-0.41533916666666926</c:v>
                </c:pt>
                <c:pt idx="28">
                  <c:v>-0.41533916666666926</c:v>
                </c:pt>
                <c:pt idx="29">
                  <c:v>-0.41533916666666926</c:v>
                </c:pt>
                <c:pt idx="30">
                  <c:v>3.6561619999999841</c:v>
                </c:pt>
                <c:pt idx="31">
                  <c:v>3.6561619999999841</c:v>
                </c:pt>
                <c:pt idx="32">
                  <c:v>3.6561619999999841</c:v>
                </c:pt>
                <c:pt idx="33">
                  <c:v>0.2783085000000014</c:v>
                </c:pt>
                <c:pt idx="34">
                  <c:v>0.2783085000000014</c:v>
                </c:pt>
                <c:pt idx="35">
                  <c:v>0.2783085000000014</c:v>
                </c:pt>
                <c:pt idx="36">
                  <c:v>-0.38026033333333586</c:v>
                </c:pt>
                <c:pt idx="37">
                  <c:v>-0.38026033333333586</c:v>
                </c:pt>
                <c:pt idx="38">
                  <c:v>-0.38026033333333586</c:v>
                </c:pt>
                <c:pt idx="39">
                  <c:v>0.49980466666666956</c:v>
                </c:pt>
                <c:pt idx="40">
                  <c:v>0.49980466666666956</c:v>
                </c:pt>
                <c:pt idx="41">
                  <c:v>0.49980466666666956</c:v>
                </c:pt>
                <c:pt idx="42">
                  <c:v>0.38083950000000044</c:v>
                </c:pt>
                <c:pt idx="43">
                  <c:v>0.38083950000000044</c:v>
                </c:pt>
                <c:pt idx="44">
                  <c:v>0.3808395000000004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34432"/>
        <c:axId val="80635008"/>
      </c:scatterChart>
      <c:valAx>
        <c:axId val="80634432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crossAx val="80635008"/>
        <c:crosses val="autoZero"/>
        <c:crossBetween val="midCat"/>
        <c:majorUnit val="5"/>
      </c:valAx>
      <c:valAx>
        <c:axId val="80635008"/>
        <c:scaling>
          <c:orientation val="minMax"/>
          <c:min val="-1"/>
        </c:scaling>
        <c:delete val="0"/>
        <c:axPos val="l"/>
        <c:numFmt formatCode="General" sourceLinked="1"/>
        <c:majorTickMark val="out"/>
        <c:minorTickMark val="none"/>
        <c:tickLblPos val="nextTo"/>
        <c:crossAx val="80634432"/>
        <c:crosses val="autoZero"/>
        <c:crossBetween val="midCat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4SB_Average (paper)'!$S$6</c:f>
              <c:strCache>
                <c:ptCount val="1"/>
                <c:pt idx="0">
                  <c:v>ΔΔCt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6:$BL$6</c:f>
              <c:numCache>
                <c:formatCode>General</c:formatCode>
                <c:ptCount val="45"/>
                <c:pt idx="1">
                  <c:v>4.5236896666666624</c:v>
                </c:pt>
                <c:pt idx="4">
                  <c:v>-0.39492300000000569</c:v>
                </c:pt>
                <c:pt idx="7">
                  <c:v>0.59823199999999943</c:v>
                </c:pt>
                <c:pt idx="10">
                  <c:v>0.56604533333332796</c:v>
                </c:pt>
                <c:pt idx="13">
                  <c:v>0.4197526666666711</c:v>
                </c:pt>
                <c:pt idx="16">
                  <c:v>3.4270648333333291</c:v>
                </c:pt>
                <c:pt idx="19">
                  <c:v>0.2218754999999959</c:v>
                </c:pt>
                <c:pt idx="22">
                  <c:v>0.29336616666666515</c:v>
                </c:pt>
                <c:pt idx="25">
                  <c:v>-0.17894450000000006</c:v>
                </c:pt>
                <c:pt idx="28">
                  <c:v>1.3756515</c:v>
                </c:pt>
                <c:pt idx="31">
                  <c:v>3.2151093333333307</c:v>
                </c:pt>
                <c:pt idx="34">
                  <c:v>0.36804566666666361</c:v>
                </c:pt>
                <c:pt idx="37">
                  <c:v>-0.19125466666666568</c:v>
                </c:pt>
                <c:pt idx="40">
                  <c:v>0.28830533333333008</c:v>
                </c:pt>
                <c:pt idx="43">
                  <c:v>1.043615000000002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4SB_Average (paper)'!$S$7</c:f>
              <c:strCache>
                <c:ptCount val="1"/>
                <c:pt idx="0">
                  <c:v>ΔΔCt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  <c:spPr>
              <a:ln w="28575"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7:$BL$7</c:f>
              <c:numCache>
                <c:formatCode>General</c:formatCode>
                <c:ptCount val="45"/>
                <c:pt idx="1">
                  <c:v>2.5277898333333368</c:v>
                </c:pt>
                <c:pt idx="4">
                  <c:v>0.3384718333333403</c:v>
                </c:pt>
                <c:pt idx="7">
                  <c:v>5.5583333333686369E-4</c:v>
                </c:pt>
                <c:pt idx="10">
                  <c:v>-0.18088783333333325</c:v>
                </c:pt>
                <c:pt idx="13">
                  <c:v>8.5593499999998102E-2</c:v>
                </c:pt>
                <c:pt idx="16">
                  <c:v>1.4056553333333284</c:v>
                </c:pt>
                <c:pt idx="19">
                  <c:v>0.50412999999999997</c:v>
                </c:pt>
                <c:pt idx="22">
                  <c:v>-0.31396833333333163</c:v>
                </c:pt>
                <c:pt idx="25">
                  <c:v>-8.068633333333608E-2</c:v>
                </c:pt>
                <c:pt idx="28">
                  <c:v>0.61158999999999608</c:v>
                </c:pt>
                <c:pt idx="31">
                  <c:v>2.2212720000000026</c:v>
                </c:pt>
                <c:pt idx="34">
                  <c:v>1.1321000000000119</c:v>
                </c:pt>
                <c:pt idx="37">
                  <c:v>-0.27803899999999615</c:v>
                </c:pt>
                <c:pt idx="40">
                  <c:v>-0.2756410000000038</c:v>
                </c:pt>
                <c:pt idx="43">
                  <c:v>0.9153176666666700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4SB_Average (paper)'!$S$8</c:f>
              <c:strCache>
                <c:ptCount val="1"/>
                <c:pt idx="0">
                  <c:v>ΔΔCt Average 1+2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dPt>
            <c:idx val="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5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7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8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FF0000"/>
                </a:solidFill>
              </a:ln>
            </c:spPr>
          </c:dPt>
          <c:dPt>
            <c:idx val="2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21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3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4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6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7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9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8:$BL$8</c:f>
              <c:numCache>
                <c:formatCode>General</c:formatCode>
                <c:ptCount val="45"/>
                <c:pt idx="0">
                  <c:v>3.5257397499999996</c:v>
                </c:pt>
                <c:pt idx="1">
                  <c:v>3.5257397499999996</c:v>
                </c:pt>
                <c:pt idx="2">
                  <c:v>3.5257397499999996</c:v>
                </c:pt>
                <c:pt idx="3">
                  <c:v>-2.8225583333332693E-2</c:v>
                </c:pt>
                <c:pt idx="4">
                  <c:v>-2.8225583333332693E-2</c:v>
                </c:pt>
                <c:pt idx="5">
                  <c:v>-2.8225583333332693E-2</c:v>
                </c:pt>
                <c:pt idx="6">
                  <c:v>0.29939391666666815</c:v>
                </c:pt>
                <c:pt idx="7">
                  <c:v>0.29939391666666815</c:v>
                </c:pt>
                <c:pt idx="8">
                  <c:v>0.29939391666666815</c:v>
                </c:pt>
                <c:pt idx="9">
                  <c:v>0.19257874999999736</c:v>
                </c:pt>
                <c:pt idx="10">
                  <c:v>0.19257874999999736</c:v>
                </c:pt>
                <c:pt idx="11">
                  <c:v>0.19257874999999736</c:v>
                </c:pt>
                <c:pt idx="12">
                  <c:v>0.2526730833333346</c:v>
                </c:pt>
                <c:pt idx="13">
                  <c:v>0.2526730833333346</c:v>
                </c:pt>
                <c:pt idx="14">
                  <c:v>0.2526730833333346</c:v>
                </c:pt>
                <c:pt idx="15">
                  <c:v>2.4163600833333287</c:v>
                </c:pt>
                <c:pt idx="16">
                  <c:v>2.4163600833333287</c:v>
                </c:pt>
                <c:pt idx="17">
                  <c:v>2.4163600833333287</c:v>
                </c:pt>
                <c:pt idx="18">
                  <c:v>0.36300274999999793</c:v>
                </c:pt>
                <c:pt idx="19">
                  <c:v>0.36300274999999793</c:v>
                </c:pt>
                <c:pt idx="20">
                  <c:v>0.36300274999999793</c:v>
                </c:pt>
                <c:pt idx="21">
                  <c:v>-1.0301083333333239E-2</c:v>
                </c:pt>
                <c:pt idx="22">
                  <c:v>-1.0301083333333239E-2</c:v>
                </c:pt>
                <c:pt idx="23">
                  <c:v>-1.0301083333333239E-2</c:v>
                </c:pt>
                <c:pt idx="24">
                  <c:v>-0.12981541666666807</c:v>
                </c:pt>
                <c:pt idx="25">
                  <c:v>-0.12981541666666807</c:v>
                </c:pt>
                <c:pt idx="26">
                  <c:v>-0.12981541666666807</c:v>
                </c:pt>
                <c:pt idx="27">
                  <c:v>0.99362074999999805</c:v>
                </c:pt>
                <c:pt idx="28">
                  <c:v>0.99362074999999805</c:v>
                </c:pt>
                <c:pt idx="29">
                  <c:v>0.99362074999999805</c:v>
                </c:pt>
                <c:pt idx="30">
                  <c:v>2.7181906666666666</c:v>
                </c:pt>
                <c:pt idx="31">
                  <c:v>2.7181906666666666</c:v>
                </c:pt>
                <c:pt idx="32">
                  <c:v>2.7181906666666666</c:v>
                </c:pt>
                <c:pt idx="33">
                  <c:v>0.75007283333333774</c:v>
                </c:pt>
                <c:pt idx="34">
                  <c:v>0.75007283333333774</c:v>
                </c:pt>
                <c:pt idx="35">
                  <c:v>0.75007283333333774</c:v>
                </c:pt>
                <c:pt idx="36">
                  <c:v>-0.23464683333333092</c:v>
                </c:pt>
                <c:pt idx="37">
                  <c:v>-0.23464683333333092</c:v>
                </c:pt>
                <c:pt idx="38">
                  <c:v>-0.23464683333333092</c:v>
                </c:pt>
                <c:pt idx="39">
                  <c:v>6.3321666666631415E-3</c:v>
                </c:pt>
                <c:pt idx="40">
                  <c:v>6.3321666666631415E-3</c:v>
                </c:pt>
                <c:pt idx="41">
                  <c:v>6.3321666666631415E-3</c:v>
                </c:pt>
                <c:pt idx="42">
                  <c:v>0.97946633333333633</c:v>
                </c:pt>
                <c:pt idx="43">
                  <c:v>0.97946633333333633</c:v>
                </c:pt>
                <c:pt idx="44">
                  <c:v>0.979466333333336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36736"/>
        <c:axId val="80637312"/>
      </c:scatterChart>
      <c:valAx>
        <c:axId val="80636736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crossAx val="80637312"/>
        <c:crosses val="autoZero"/>
        <c:crossBetween val="midCat"/>
        <c:majorUnit val="5"/>
      </c:valAx>
      <c:valAx>
        <c:axId val="80637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063673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S4C (paper)'!$P$5</c:f>
              <c:strCache>
                <c:ptCount val="1"/>
                <c:pt idx="0">
                  <c:v>Average 1</c:v>
                </c:pt>
              </c:strCache>
            </c:strRef>
          </c:tx>
          <c:spPr>
            <a:ln w="28575">
              <a:solidFill>
                <a:schemeClr val="bg1">
                  <a:lumMod val="65000"/>
                </a:schemeClr>
              </a:solidFill>
            </a:ln>
          </c:spPr>
          <c:marker>
            <c:symbol val="diamond"/>
            <c:size val="5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xVal>
            <c:numRef>
              <c:f>'Fig.S4C (paper)'!$Q$4:$Y$4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4C (paper)'!$Q$5:$Y$5</c:f>
              <c:numCache>
                <c:formatCode>General</c:formatCode>
                <c:ptCount val="9"/>
                <c:pt idx="1">
                  <c:v>0.375</c:v>
                </c:pt>
                <c:pt idx="4">
                  <c:v>0.39329268292682923</c:v>
                </c:pt>
                <c:pt idx="7">
                  <c:v>2.231707317073170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S4C (paper)'!$P$6</c:f>
              <c:strCache>
                <c:ptCount val="1"/>
                <c:pt idx="0">
                  <c:v>Average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xVal>
            <c:numRef>
              <c:f>'Fig.S4C (paper)'!$Q$4:$Y$4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4C (paper)'!$Q$6:$Y$6</c:f>
              <c:numCache>
                <c:formatCode>General</c:formatCode>
                <c:ptCount val="9"/>
                <c:pt idx="1">
                  <c:v>0.34418899635325828</c:v>
                </c:pt>
                <c:pt idx="4">
                  <c:v>0.50442999841446012</c:v>
                </c:pt>
                <c:pt idx="7">
                  <c:v>2.151381005232281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S4C (paper)'!$P$7</c:f>
              <c:strCache>
                <c:ptCount val="1"/>
                <c:pt idx="0">
                  <c:v>Average 3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xVal>
            <c:numRef>
              <c:f>'Fig.S4C (paper)'!$Q$4:$Y$4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4C (paper)'!$Q$7:$Y$7</c:f>
              <c:numCache>
                <c:formatCode>General</c:formatCode>
                <c:ptCount val="9"/>
                <c:pt idx="1">
                  <c:v>0.14616327869984974</c:v>
                </c:pt>
                <c:pt idx="4">
                  <c:v>0.45247923179219707</c:v>
                </c:pt>
                <c:pt idx="7">
                  <c:v>2.401357489507953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.S4C (paper)'!$P$8</c:f>
              <c:strCache>
                <c:ptCount val="1"/>
                <c:pt idx="0">
                  <c:v>Average 1+2+3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.S4C (paper)'!$Q$9:$Y$9</c:f>
                <c:numCache>
                  <c:formatCode>General</c:formatCode>
                  <c:ptCount val="9"/>
                  <c:pt idx="1">
                    <c:v>7.169757000890381E-2</c:v>
                  </c:pt>
                  <c:pt idx="4">
                    <c:v>3.2105237209519064E-2</c:v>
                  </c:pt>
                  <c:pt idx="7">
                    <c:v>7.3681650087060513E-2</c:v>
                  </c:pt>
                </c:numCache>
              </c:numRef>
            </c:plus>
            <c:minus>
              <c:numRef>
                <c:f>'Fig.S4C (paper)'!$Q$9:$Y$9</c:f>
                <c:numCache>
                  <c:formatCode>General</c:formatCode>
                  <c:ptCount val="9"/>
                  <c:pt idx="1">
                    <c:v>7.169757000890381E-2</c:v>
                  </c:pt>
                  <c:pt idx="4">
                    <c:v>3.2105237209519064E-2</c:v>
                  </c:pt>
                  <c:pt idx="7">
                    <c:v>7.3681650087060513E-2</c:v>
                  </c:pt>
                </c:numCache>
              </c:numRef>
            </c:minus>
          </c:errBars>
          <c:xVal>
            <c:numRef>
              <c:f>'Fig.S4C (paper)'!$Q$4:$Y$4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4C (paper)'!$Q$8:$Y$8</c:f>
              <c:numCache>
                <c:formatCode>General</c:formatCode>
                <c:ptCount val="9"/>
                <c:pt idx="0">
                  <c:v>0.28845075835103601</c:v>
                </c:pt>
                <c:pt idx="1">
                  <c:v>0.28845075835103601</c:v>
                </c:pt>
                <c:pt idx="2">
                  <c:v>0.28845075835103601</c:v>
                </c:pt>
                <c:pt idx="3">
                  <c:v>0.45006730437782877</c:v>
                </c:pt>
                <c:pt idx="4">
                  <c:v>0.45006730437782877</c:v>
                </c:pt>
                <c:pt idx="5">
                  <c:v>0.45006730437782877</c:v>
                </c:pt>
                <c:pt idx="6">
                  <c:v>2.2614819372711352</c:v>
                </c:pt>
                <c:pt idx="7">
                  <c:v>2.2614819372711352</c:v>
                </c:pt>
                <c:pt idx="8">
                  <c:v>2.261481937271135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39616"/>
        <c:axId val="80640192"/>
      </c:scatterChart>
      <c:valAx>
        <c:axId val="80639616"/>
        <c:scaling>
          <c:orientation val="minMax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crossAx val="80640192"/>
        <c:crosses val="autoZero"/>
        <c:crossBetween val="midCat"/>
        <c:majorUnit val="1"/>
      </c:valAx>
      <c:valAx>
        <c:axId val="80640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0639616"/>
        <c:crosses val="autoZero"/>
        <c:crossBetween val="midCat"/>
        <c:majorUnit val="0.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4642920661611346E-2"/>
          <c:y val="3.5824537890210534E-2"/>
          <c:w val="0.89198963065961723"/>
          <c:h val="0.87179371195621824"/>
        </c:manualLayout>
      </c:layout>
      <c:scatterChart>
        <c:scatterStyle val="lineMarker"/>
        <c:varyColors val="0"/>
        <c:ser>
          <c:idx val="0"/>
          <c:order val="0"/>
          <c:tx>
            <c:v>Serie 1</c:v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bg1">
                  <a:lumMod val="50000"/>
                </a:schemeClr>
              </a:solidFill>
              <a:ln>
                <a:noFill/>
              </a:ln>
            </c:spPr>
          </c:marker>
          <c:xVal>
            <c:numRef>
              <c:f>'Fig.S4A average (paper)'!$N$8:$AC$8</c:f>
              <c:numCache>
                <c:formatCode>General</c:formatCode>
                <c:ptCount val="16"/>
                <c:pt idx="0">
                  <c:v>1</c:v>
                </c:pt>
                <c:pt idx="1">
                  <c:v>1.1000000000000001</c:v>
                </c:pt>
                <c:pt idx="2">
                  <c:v>1.9</c:v>
                </c:pt>
                <c:pt idx="3">
                  <c:v>2</c:v>
                </c:pt>
                <c:pt idx="4">
                  <c:v>2.1</c:v>
                </c:pt>
                <c:pt idx="5">
                  <c:v>2.9</c:v>
                </c:pt>
                <c:pt idx="6">
                  <c:v>3</c:v>
                </c:pt>
                <c:pt idx="7">
                  <c:v>3.1</c:v>
                </c:pt>
                <c:pt idx="8">
                  <c:v>3.9</c:v>
                </c:pt>
                <c:pt idx="9">
                  <c:v>4</c:v>
                </c:pt>
                <c:pt idx="10">
                  <c:v>4.0999999999999996</c:v>
                </c:pt>
                <c:pt idx="11">
                  <c:v>4.9000000000000004</c:v>
                </c:pt>
                <c:pt idx="12">
                  <c:v>5</c:v>
                </c:pt>
                <c:pt idx="13">
                  <c:v>5.0999999999999996</c:v>
                </c:pt>
                <c:pt idx="14">
                  <c:v>5.9</c:v>
                </c:pt>
                <c:pt idx="15">
                  <c:v>6</c:v>
                </c:pt>
              </c:numCache>
            </c:numRef>
          </c:xVal>
          <c:yVal>
            <c:numRef>
              <c:f>'Fig.S4A average (paper)'!$N$11:$AC$11</c:f>
              <c:numCache>
                <c:formatCode>General</c:formatCode>
                <c:ptCount val="16"/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xVal>
            <c:numRef>
              <c:f>'Fig.S4A average (paper)'!$N$8:$AC$8</c:f>
              <c:numCache>
                <c:formatCode>General</c:formatCode>
                <c:ptCount val="16"/>
                <c:pt idx="0">
                  <c:v>1</c:v>
                </c:pt>
                <c:pt idx="1">
                  <c:v>1.1000000000000001</c:v>
                </c:pt>
                <c:pt idx="2">
                  <c:v>1.9</c:v>
                </c:pt>
                <c:pt idx="3">
                  <c:v>2</c:v>
                </c:pt>
                <c:pt idx="4">
                  <c:v>2.1</c:v>
                </c:pt>
                <c:pt idx="5">
                  <c:v>2.9</c:v>
                </c:pt>
                <c:pt idx="6">
                  <c:v>3</c:v>
                </c:pt>
                <c:pt idx="7">
                  <c:v>3.1</c:v>
                </c:pt>
                <c:pt idx="8">
                  <c:v>3.9</c:v>
                </c:pt>
                <c:pt idx="9">
                  <c:v>4</c:v>
                </c:pt>
                <c:pt idx="10">
                  <c:v>4.0999999999999996</c:v>
                </c:pt>
                <c:pt idx="11">
                  <c:v>4.9000000000000004</c:v>
                </c:pt>
                <c:pt idx="12">
                  <c:v>5</c:v>
                </c:pt>
                <c:pt idx="13">
                  <c:v>5.0999999999999996</c:v>
                </c:pt>
                <c:pt idx="14">
                  <c:v>5.9</c:v>
                </c:pt>
                <c:pt idx="15">
                  <c:v>6</c:v>
                </c:pt>
              </c:numCache>
            </c:numRef>
          </c:xVal>
          <c:yVal>
            <c:numRef>
              <c:f>'Fig.S4A average (paper)'!$N$10:$AC$10</c:f>
              <c:numCache>
                <c:formatCode>General</c:formatCode>
                <c:ptCount val="16"/>
                <c:pt idx="0">
                  <c:v>2.6399319727891157</c:v>
                </c:pt>
                <c:pt idx="3">
                  <c:v>1.8245920745920747</c:v>
                </c:pt>
                <c:pt idx="6">
                  <c:v>2.5336544109009749</c:v>
                </c:pt>
                <c:pt idx="9">
                  <c:v>13.299766150248466</c:v>
                </c:pt>
                <c:pt idx="12">
                  <c:v>13.844633754626074</c:v>
                </c:pt>
                <c:pt idx="15">
                  <c:v>11.162414610344346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.S4A average (paper)'!$M$13:$AD$13</c:f>
                <c:numCache>
                  <c:formatCode>General</c:formatCode>
                  <c:ptCount val="18"/>
                </c:numCache>
              </c:numRef>
            </c:plus>
            <c:minus>
              <c:numRef>
                <c:f>'Fig.S4A average (paper)'!$M$13:$AD$13</c:f>
                <c:numCache>
                  <c:formatCode>General</c:formatCode>
                  <c:ptCount val="18"/>
                </c:numCache>
              </c:numRef>
            </c:minus>
          </c:errBars>
          <c:xVal>
            <c:numRef>
              <c:f>'Fig.S4A average (paper)'!$M$8:$AD$8</c:f>
              <c:numCache>
                <c:formatCode>General</c:formatCode>
                <c:ptCount val="18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</c:numCache>
            </c:numRef>
          </c:xVal>
          <c:yVal>
            <c:numRef>
              <c:f>'Fig.S4A average (paper)'!$M$12:$AD$12</c:f>
              <c:numCache>
                <c:formatCode>General</c:formatCode>
                <c:ptCount val="18"/>
                <c:pt idx="0">
                  <c:v>5.2703957250144429</c:v>
                </c:pt>
                <c:pt idx="1">
                  <c:v>5.2703957250144429</c:v>
                </c:pt>
                <c:pt idx="2">
                  <c:v>5.2703957250144429</c:v>
                </c:pt>
                <c:pt idx="3">
                  <c:v>6.4595215887163775</c:v>
                </c:pt>
                <c:pt idx="4">
                  <c:v>6.4595215887163775</c:v>
                </c:pt>
                <c:pt idx="5">
                  <c:v>6.4595215887163775</c:v>
                </c:pt>
                <c:pt idx="6">
                  <c:v>6.1207317391033733</c:v>
                </c:pt>
                <c:pt idx="7">
                  <c:v>6.1207317391033733</c:v>
                </c:pt>
                <c:pt idx="8">
                  <c:v>6.1207317391033733</c:v>
                </c:pt>
                <c:pt idx="9">
                  <c:v>17.856816593557056</c:v>
                </c:pt>
                <c:pt idx="10">
                  <c:v>17.856816593557056</c:v>
                </c:pt>
                <c:pt idx="11">
                  <c:v>17.856816593557056</c:v>
                </c:pt>
                <c:pt idx="12">
                  <c:v>20.426119024407868</c:v>
                </c:pt>
                <c:pt idx="13">
                  <c:v>20.426119024407868</c:v>
                </c:pt>
                <c:pt idx="14">
                  <c:v>20.426119024407868</c:v>
                </c:pt>
                <c:pt idx="15">
                  <c:v>19.501268452141076</c:v>
                </c:pt>
                <c:pt idx="16">
                  <c:v>19.501268452141076</c:v>
                </c:pt>
                <c:pt idx="17">
                  <c:v>19.501268452141076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c:spPr>
          </c:marker>
          <c:xVal>
            <c:numRef>
              <c:f>'Fig.S4A average (paper)'!$M$8:$AC$8</c:f>
              <c:numCache>
                <c:formatCode>General</c:formatCode>
                <c:ptCount val="17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</c:numCache>
            </c:numRef>
          </c:xVal>
          <c:yVal>
            <c:numRef>
              <c:f>'Fig.S4A average (paper)'!$M$9:$AC$9</c:f>
              <c:numCache>
                <c:formatCode>General</c:formatCode>
                <c:ptCount val="17"/>
                <c:pt idx="1">
                  <c:v>7.90085947723977</c:v>
                </c:pt>
                <c:pt idx="4">
                  <c:v>11.094451102840681</c:v>
                </c:pt>
                <c:pt idx="7">
                  <c:v>9.7078090673057726</c:v>
                </c:pt>
                <c:pt idx="10">
                  <c:v>22.41386703686565</c:v>
                </c:pt>
                <c:pt idx="13">
                  <c:v>27.007604294189662</c:v>
                </c:pt>
                <c:pt idx="16">
                  <c:v>27.8401222939378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207296"/>
        <c:axId val="83208448"/>
      </c:scatterChart>
      <c:valAx>
        <c:axId val="83207296"/>
        <c:scaling>
          <c:orientation val="minMax"/>
          <c:max val="7"/>
        </c:scaling>
        <c:delete val="0"/>
        <c:axPos val="b"/>
        <c:numFmt formatCode="General" sourceLinked="1"/>
        <c:majorTickMark val="out"/>
        <c:minorTickMark val="none"/>
        <c:tickLblPos val="none"/>
        <c:txPr>
          <a:bodyPr rot="0" vert="horz"/>
          <a:lstStyle/>
          <a:p>
            <a:pPr>
              <a:defRPr/>
            </a:pPr>
            <a:endParaRPr lang="it-IT"/>
          </a:p>
        </c:txPr>
        <c:crossAx val="83208448"/>
        <c:crosses val="autoZero"/>
        <c:crossBetween val="midCat"/>
        <c:majorUnit val="1"/>
      </c:valAx>
      <c:valAx>
        <c:axId val="83208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320729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4SB_Average (paper)'!$S$14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14:$BL$14</c:f>
              <c:numCache>
                <c:formatCode>General</c:formatCode>
                <c:ptCount val="45"/>
                <c:pt idx="1">
                  <c:v>4.8460278333333306</c:v>
                </c:pt>
                <c:pt idx="4">
                  <c:v>5.2954171666666596</c:v>
                </c:pt>
                <c:pt idx="7">
                  <c:v>1.1046015000000047</c:v>
                </c:pt>
                <c:pt idx="10">
                  <c:v>0.53534616666666679</c:v>
                </c:pt>
                <c:pt idx="13">
                  <c:v>1.536035499999997</c:v>
                </c:pt>
                <c:pt idx="16">
                  <c:v>4.548542833333336</c:v>
                </c:pt>
                <c:pt idx="19">
                  <c:v>4.964958166666662</c:v>
                </c:pt>
                <c:pt idx="22">
                  <c:v>1.2946325000000023</c:v>
                </c:pt>
                <c:pt idx="25">
                  <c:v>0.35236683333333474</c:v>
                </c:pt>
                <c:pt idx="28">
                  <c:v>2.2787701666666642</c:v>
                </c:pt>
                <c:pt idx="31">
                  <c:v>4.2174704999999975</c:v>
                </c:pt>
                <c:pt idx="34">
                  <c:v>5.4687174999999932</c:v>
                </c:pt>
                <c:pt idx="37">
                  <c:v>0.97101683333333355</c:v>
                </c:pt>
                <c:pt idx="40">
                  <c:v>1.0257524999999994</c:v>
                </c:pt>
                <c:pt idx="43">
                  <c:v>2.326036833333333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4SB_Average (paper)'!$S$15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</c:marker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  <c:spPr>
              <a:ln w="28575"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15:$BL$15</c:f>
              <c:numCache>
                <c:formatCode>General</c:formatCode>
                <c:ptCount val="45"/>
                <c:pt idx="1">
                  <c:v>4.4182243333333346</c:v>
                </c:pt>
                <c:pt idx="4">
                  <c:v>5.0886246666666715</c:v>
                </c:pt>
                <c:pt idx="7">
                  <c:v>0.78863700000000136</c:v>
                </c:pt>
                <c:pt idx="10">
                  <c:v>0.34514400000000123</c:v>
                </c:pt>
                <c:pt idx="13">
                  <c:v>2.8867210000000014</c:v>
                </c:pt>
                <c:pt idx="16">
                  <c:v>4.6874583333333355</c:v>
                </c:pt>
                <c:pt idx="19">
                  <c:v>5.3615890000000022</c:v>
                </c:pt>
                <c:pt idx="22">
                  <c:v>0.71140199999999609</c:v>
                </c:pt>
                <c:pt idx="25">
                  <c:v>0.27443033333333133</c:v>
                </c:pt>
                <c:pt idx="28">
                  <c:v>2.9690373333333326</c:v>
                </c:pt>
                <c:pt idx="31">
                  <c:v>4.8793523333333333</c:v>
                </c:pt>
                <c:pt idx="34">
                  <c:v>6.3978456666666723</c:v>
                </c:pt>
                <c:pt idx="37">
                  <c:v>0.96600533333333161</c:v>
                </c:pt>
                <c:pt idx="40">
                  <c:v>0.39453600000000222</c:v>
                </c:pt>
                <c:pt idx="43">
                  <c:v>4.0962563333333364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4SB_Average (paper)'!$S$16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dPt>
            <c:idx val="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1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15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7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18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FF0000"/>
                </a:solidFill>
              </a:ln>
            </c:spPr>
          </c:dPt>
          <c:dPt>
            <c:idx val="2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00B050"/>
                </a:solidFill>
              </a:ln>
            </c:spPr>
          </c:dPt>
          <c:dPt>
            <c:idx val="21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3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24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5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6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27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8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29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30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1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2"/>
            <c:marker>
              <c:spPr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c:spPr>
            </c:marker>
            <c:bubble3D val="0"/>
          </c:dPt>
          <c:dPt>
            <c:idx val="3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6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8"/>
            <c:marker>
              <c:spPr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c:spPr>
            </c:marker>
            <c:bubble3D val="0"/>
          </c:dPt>
          <c:dPt>
            <c:idx val="39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0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1"/>
            <c:marker>
              <c:spPr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c:spPr>
            </c:marker>
            <c:bubble3D val="0"/>
          </c:dPt>
          <c:dPt>
            <c:idx val="42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3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dPt>
            <c:idx val="44"/>
            <c:marker>
              <c:spPr>
                <a:solidFill>
                  <a:schemeClr val="tx2">
                    <a:lumMod val="60000"/>
                    <a:lumOff val="40000"/>
                  </a:schemeClr>
                </a:solidFill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</c:spPr>
            </c:marker>
            <c:bubble3D val="0"/>
          </c:dPt>
          <c:xVal>
            <c:numRef>
              <c:f>'Fig.4SB_Average (paper)'!$T$5:$BL$5</c:f>
              <c:numCache>
                <c:formatCode>General</c:formatCode>
                <c:ptCount val="45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7.9</c:v>
                </c:pt>
                <c:pt idx="16">
                  <c:v>8</c:v>
                </c:pt>
                <c:pt idx="17">
                  <c:v>8.1</c:v>
                </c:pt>
                <c:pt idx="18">
                  <c:v>8.9</c:v>
                </c:pt>
                <c:pt idx="19">
                  <c:v>9</c:v>
                </c:pt>
                <c:pt idx="20">
                  <c:v>9.1</c:v>
                </c:pt>
                <c:pt idx="21">
                  <c:v>9.9</c:v>
                </c:pt>
                <c:pt idx="22">
                  <c:v>10</c:v>
                </c:pt>
                <c:pt idx="23">
                  <c:v>10.1</c:v>
                </c:pt>
                <c:pt idx="24">
                  <c:v>10.9</c:v>
                </c:pt>
                <c:pt idx="25">
                  <c:v>11</c:v>
                </c:pt>
                <c:pt idx="26">
                  <c:v>11.1</c:v>
                </c:pt>
                <c:pt idx="27">
                  <c:v>11.9</c:v>
                </c:pt>
                <c:pt idx="28">
                  <c:v>12</c:v>
                </c:pt>
                <c:pt idx="29">
                  <c:v>12.1</c:v>
                </c:pt>
                <c:pt idx="30">
                  <c:v>14.9</c:v>
                </c:pt>
                <c:pt idx="31">
                  <c:v>15</c:v>
                </c:pt>
                <c:pt idx="32">
                  <c:v>15.1</c:v>
                </c:pt>
                <c:pt idx="33">
                  <c:v>15.9</c:v>
                </c:pt>
                <c:pt idx="34">
                  <c:v>16</c:v>
                </c:pt>
                <c:pt idx="35">
                  <c:v>16.100000000000001</c:v>
                </c:pt>
                <c:pt idx="36">
                  <c:v>16.899999999999999</c:v>
                </c:pt>
                <c:pt idx="37">
                  <c:v>17</c:v>
                </c:pt>
                <c:pt idx="38">
                  <c:v>17.100000000000001</c:v>
                </c:pt>
                <c:pt idx="39">
                  <c:v>17.899999999999999</c:v>
                </c:pt>
                <c:pt idx="40">
                  <c:v>18</c:v>
                </c:pt>
                <c:pt idx="41">
                  <c:v>18.100000000000001</c:v>
                </c:pt>
                <c:pt idx="42">
                  <c:v>18.899999999999999</c:v>
                </c:pt>
                <c:pt idx="43">
                  <c:v>19</c:v>
                </c:pt>
                <c:pt idx="44">
                  <c:v>19.100000000000001</c:v>
                </c:pt>
              </c:numCache>
            </c:numRef>
          </c:xVal>
          <c:yVal>
            <c:numRef>
              <c:f>'Fig.4SB_Average (paper)'!$T$16:$BL$16</c:f>
              <c:numCache>
                <c:formatCode>General</c:formatCode>
                <c:ptCount val="45"/>
                <c:pt idx="0">
                  <c:v>4.6321260833333326</c:v>
                </c:pt>
                <c:pt idx="1">
                  <c:v>4.6321260833333326</c:v>
                </c:pt>
                <c:pt idx="2">
                  <c:v>4.6321260833333326</c:v>
                </c:pt>
                <c:pt idx="3">
                  <c:v>5.1920209166666655</c:v>
                </c:pt>
                <c:pt idx="4">
                  <c:v>5.1920209166666655</c:v>
                </c:pt>
                <c:pt idx="5">
                  <c:v>5.1920209166666655</c:v>
                </c:pt>
                <c:pt idx="6">
                  <c:v>0.94661925000000302</c:v>
                </c:pt>
                <c:pt idx="7">
                  <c:v>0.94661925000000302</c:v>
                </c:pt>
                <c:pt idx="8">
                  <c:v>0.94661925000000302</c:v>
                </c:pt>
                <c:pt idx="9">
                  <c:v>0.44024508333333401</c:v>
                </c:pt>
                <c:pt idx="10">
                  <c:v>0.44024508333333401</c:v>
                </c:pt>
                <c:pt idx="11">
                  <c:v>0.44024508333333401</c:v>
                </c:pt>
                <c:pt idx="12">
                  <c:v>2.2113782499999992</c:v>
                </c:pt>
                <c:pt idx="13">
                  <c:v>2.2113782499999992</c:v>
                </c:pt>
                <c:pt idx="14">
                  <c:v>2.2113782499999992</c:v>
                </c:pt>
                <c:pt idx="15">
                  <c:v>4.6180005833333357</c:v>
                </c:pt>
                <c:pt idx="16">
                  <c:v>4.6180005833333357</c:v>
                </c:pt>
                <c:pt idx="17">
                  <c:v>4.6180005833333357</c:v>
                </c:pt>
                <c:pt idx="18">
                  <c:v>5.1632735833333321</c:v>
                </c:pt>
                <c:pt idx="19">
                  <c:v>5.1632735833333321</c:v>
                </c:pt>
                <c:pt idx="20">
                  <c:v>5.1632735833333321</c:v>
                </c:pt>
                <c:pt idx="21">
                  <c:v>1.0030172499999992</c:v>
                </c:pt>
                <c:pt idx="22">
                  <c:v>1.0030172499999992</c:v>
                </c:pt>
                <c:pt idx="23">
                  <c:v>1.0030172499999992</c:v>
                </c:pt>
                <c:pt idx="24">
                  <c:v>0.31339858333333304</c:v>
                </c:pt>
                <c:pt idx="25">
                  <c:v>0.31339858333333304</c:v>
                </c:pt>
                <c:pt idx="26">
                  <c:v>0.31339858333333304</c:v>
                </c:pt>
                <c:pt idx="27">
                  <c:v>2.6239037499999984</c:v>
                </c:pt>
                <c:pt idx="28">
                  <c:v>2.6239037499999984</c:v>
                </c:pt>
                <c:pt idx="29">
                  <c:v>2.6239037499999984</c:v>
                </c:pt>
                <c:pt idx="30">
                  <c:v>4.5484114166666654</c:v>
                </c:pt>
                <c:pt idx="31">
                  <c:v>4.5484114166666654</c:v>
                </c:pt>
                <c:pt idx="32">
                  <c:v>4.5484114166666654</c:v>
                </c:pt>
                <c:pt idx="33">
                  <c:v>5.9332815833333328</c:v>
                </c:pt>
                <c:pt idx="34">
                  <c:v>5.9332815833333328</c:v>
                </c:pt>
                <c:pt idx="35">
                  <c:v>5.9332815833333328</c:v>
                </c:pt>
                <c:pt idx="36">
                  <c:v>0.96851108333333258</c:v>
                </c:pt>
                <c:pt idx="37">
                  <c:v>0.96851108333333258</c:v>
                </c:pt>
                <c:pt idx="38">
                  <c:v>0.96851108333333258</c:v>
                </c:pt>
                <c:pt idx="39">
                  <c:v>0.71014425000000081</c:v>
                </c:pt>
                <c:pt idx="40">
                  <c:v>0.71014425000000081</c:v>
                </c:pt>
                <c:pt idx="41">
                  <c:v>0.71014425000000081</c:v>
                </c:pt>
                <c:pt idx="42">
                  <c:v>3.2111465833333348</c:v>
                </c:pt>
                <c:pt idx="43">
                  <c:v>3.2111465833333348</c:v>
                </c:pt>
                <c:pt idx="44">
                  <c:v>3.211146583333334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210176"/>
        <c:axId val="83210752"/>
      </c:scatterChart>
      <c:valAx>
        <c:axId val="83210176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crossAx val="83210752"/>
        <c:crosses val="autoZero"/>
        <c:crossBetween val="midCat"/>
        <c:majorUnit val="5"/>
      </c:valAx>
      <c:valAx>
        <c:axId val="83210752"/>
        <c:scaling>
          <c:orientation val="minMax"/>
          <c:min val="-1"/>
        </c:scaling>
        <c:delete val="0"/>
        <c:axPos val="l"/>
        <c:numFmt formatCode="General" sourceLinked="1"/>
        <c:majorTickMark val="out"/>
        <c:minorTickMark val="none"/>
        <c:tickLblPos val="nextTo"/>
        <c:crossAx val="83210176"/>
        <c:crosses val="autoZero"/>
        <c:crossBetween val="midCat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9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pPr/>
              <a:t>14/12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9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pPr/>
              <a:t>14/12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744538"/>
            <a:ext cx="25749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76147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744538"/>
            <a:ext cx="25749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pPr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89288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0" name="Chart 1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4603258"/>
              </p:ext>
            </p:extLst>
          </p:nvPr>
        </p:nvGraphicFramePr>
        <p:xfrm>
          <a:off x="448490" y="5638356"/>
          <a:ext cx="2935505" cy="16395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1" name="Chart 1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3360155"/>
              </p:ext>
            </p:extLst>
          </p:nvPr>
        </p:nvGraphicFramePr>
        <p:xfrm>
          <a:off x="3648181" y="3319095"/>
          <a:ext cx="2931169" cy="163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8" name="Chart 1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6849886"/>
              </p:ext>
            </p:extLst>
          </p:nvPr>
        </p:nvGraphicFramePr>
        <p:xfrm>
          <a:off x="442419" y="3347468"/>
          <a:ext cx="2941576" cy="1639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2" name="Chart 1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8580795"/>
              </p:ext>
            </p:extLst>
          </p:nvPr>
        </p:nvGraphicFramePr>
        <p:xfrm>
          <a:off x="422360" y="7894165"/>
          <a:ext cx="2299070" cy="15783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 Box 26"/>
          <p:cNvSpPr txBox="1">
            <a:spLocks noChangeArrowheads="1"/>
          </p:cNvSpPr>
          <p:nvPr/>
        </p:nvSpPr>
        <p:spPr bwMode="auto">
          <a:xfrm>
            <a:off x="1524000" y="330182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322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26"/>
          <p:cNvSpPr txBox="1">
            <a:spLocks noChangeArrowheads="1"/>
          </p:cNvSpPr>
          <p:nvPr/>
        </p:nvSpPr>
        <p:spPr bwMode="auto">
          <a:xfrm>
            <a:off x="4805362" y="330182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26"/>
          <p:cNvSpPr txBox="1">
            <a:spLocks noChangeArrowheads="1"/>
          </p:cNvSpPr>
          <p:nvPr/>
        </p:nvSpPr>
        <p:spPr bwMode="auto">
          <a:xfrm>
            <a:off x="1524000" y="571482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26"/>
          <p:cNvSpPr txBox="1">
            <a:spLocks noChangeArrowheads="1"/>
          </p:cNvSpPr>
          <p:nvPr/>
        </p:nvSpPr>
        <p:spPr bwMode="auto">
          <a:xfrm>
            <a:off x="4805362" y="571482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46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51"/>
          <p:cNvSpPr txBox="1">
            <a:spLocks noChangeArrowheads="1"/>
          </p:cNvSpPr>
          <p:nvPr/>
        </p:nvSpPr>
        <p:spPr bwMode="auto">
          <a:xfrm rot="16200000">
            <a:off x="-508804" y="3866242"/>
            <a:ext cx="17171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expression, Log2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ormalized to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51"/>
          <p:cNvSpPr txBox="1">
            <a:spLocks noChangeArrowheads="1"/>
          </p:cNvSpPr>
          <p:nvPr/>
        </p:nvSpPr>
        <p:spPr bwMode="auto">
          <a:xfrm rot="16200000">
            <a:off x="2722440" y="3866242"/>
            <a:ext cx="17171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expression, Log2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ormalized to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51"/>
          <p:cNvSpPr txBox="1">
            <a:spLocks noChangeArrowheads="1"/>
          </p:cNvSpPr>
          <p:nvPr/>
        </p:nvSpPr>
        <p:spPr bwMode="auto">
          <a:xfrm rot="16200000">
            <a:off x="-508804" y="6258732"/>
            <a:ext cx="17171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expression, Log2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ormalized to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 Box 51"/>
          <p:cNvSpPr txBox="1">
            <a:spLocks noChangeArrowheads="1"/>
          </p:cNvSpPr>
          <p:nvPr/>
        </p:nvSpPr>
        <p:spPr bwMode="auto">
          <a:xfrm rot="16200000">
            <a:off x="2722439" y="6258732"/>
            <a:ext cx="17171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expression, Log2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ormalized to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26"/>
          <p:cNvSpPr txBox="1">
            <a:spLocks noChangeArrowheads="1"/>
          </p:cNvSpPr>
          <p:nvPr/>
        </p:nvSpPr>
        <p:spPr bwMode="auto">
          <a:xfrm>
            <a:off x="1628800" y="300245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XIN2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 Box 26"/>
          <p:cNvSpPr txBox="1">
            <a:spLocks noChangeArrowheads="1"/>
          </p:cNvSpPr>
          <p:nvPr/>
        </p:nvSpPr>
        <p:spPr bwMode="auto">
          <a:xfrm>
            <a:off x="2284547" y="300245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GR5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26"/>
          <p:cNvSpPr txBox="1">
            <a:spLocks noChangeArrowheads="1"/>
          </p:cNvSpPr>
          <p:nvPr/>
        </p:nvSpPr>
        <p:spPr bwMode="auto">
          <a:xfrm>
            <a:off x="2940295" y="300245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26"/>
          <p:cNvSpPr txBox="1">
            <a:spLocks noChangeArrowheads="1"/>
          </p:cNvSpPr>
          <p:nvPr/>
        </p:nvSpPr>
        <p:spPr bwMode="auto">
          <a:xfrm>
            <a:off x="3596042" y="300245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OXB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26"/>
          <p:cNvSpPr txBox="1">
            <a:spLocks noChangeArrowheads="1"/>
          </p:cNvSpPr>
          <p:nvPr/>
        </p:nvSpPr>
        <p:spPr bwMode="auto">
          <a:xfrm>
            <a:off x="4251790" y="300245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EF1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 Box 49"/>
          <p:cNvSpPr txBox="1">
            <a:spLocks noChangeArrowheads="1"/>
          </p:cNvSpPr>
          <p:nvPr/>
        </p:nvSpPr>
        <p:spPr bwMode="auto">
          <a:xfrm>
            <a:off x="76200" y="247651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 Box 49"/>
          <p:cNvSpPr txBox="1">
            <a:spLocks noChangeArrowheads="1"/>
          </p:cNvSpPr>
          <p:nvPr/>
        </p:nvSpPr>
        <p:spPr bwMode="auto">
          <a:xfrm>
            <a:off x="76200" y="2678711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50"/>
          <p:cNvSpPr txBox="1">
            <a:spLocks noChangeArrowheads="1"/>
          </p:cNvSpPr>
          <p:nvPr/>
        </p:nvSpPr>
        <p:spPr bwMode="auto">
          <a:xfrm rot="16200000">
            <a:off x="-220262" y="1150306"/>
            <a:ext cx="1140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OP/FOP ratio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luciferase activity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 Box 49"/>
          <p:cNvSpPr txBox="1">
            <a:spLocks noChangeArrowheads="1"/>
          </p:cNvSpPr>
          <p:nvPr/>
        </p:nvSpPr>
        <p:spPr bwMode="auto">
          <a:xfrm>
            <a:off x="76200" y="7467601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 Box 26"/>
          <p:cNvSpPr txBox="1">
            <a:spLocks noChangeArrowheads="1"/>
          </p:cNvSpPr>
          <p:nvPr/>
        </p:nvSpPr>
        <p:spPr bwMode="auto">
          <a:xfrm>
            <a:off x="2260874" y="249124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Wnt3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/>
          <p:cNvCxnSpPr/>
          <p:nvPr/>
        </p:nvCxnSpPr>
        <p:spPr>
          <a:xfrm>
            <a:off x="2168206" y="2491096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 Box 26"/>
          <p:cNvSpPr txBox="1">
            <a:spLocks noChangeArrowheads="1"/>
          </p:cNvSpPr>
          <p:nvPr/>
        </p:nvSpPr>
        <p:spPr bwMode="auto">
          <a:xfrm rot="19102524">
            <a:off x="669540" y="214359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 Box 26"/>
          <p:cNvSpPr txBox="1">
            <a:spLocks noChangeArrowheads="1"/>
          </p:cNvSpPr>
          <p:nvPr/>
        </p:nvSpPr>
        <p:spPr bwMode="auto">
          <a:xfrm rot="19102524">
            <a:off x="1076132" y="214359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 Box 26"/>
          <p:cNvSpPr txBox="1">
            <a:spLocks noChangeArrowheads="1"/>
          </p:cNvSpPr>
          <p:nvPr/>
        </p:nvSpPr>
        <p:spPr bwMode="auto">
          <a:xfrm rot="19102524">
            <a:off x="1482724" y="214359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JNJ-BJ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 Box 26"/>
          <p:cNvSpPr txBox="1">
            <a:spLocks noChangeArrowheads="1"/>
          </p:cNvSpPr>
          <p:nvPr/>
        </p:nvSpPr>
        <p:spPr bwMode="auto">
          <a:xfrm rot="19102524">
            <a:off x="1889316" y="2149627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 Box 26"/>
          <p:cNvSpPr txBox="1">
            <a:spLocks noChangeArrowheads="1"/>
          </p:cNvSpPr>
          <p:nvPr/>
        </p:nvSpPr>
        <p:spPr bwMode="auto">
          <a:xfrm rot="19102524">
            <a:off x="2295908" y="2149627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 Box 26"/>
          <p:cNvSpPr txBox="1">
            <a:spLocks noChangeArrowheads="1"/>
          </p:cNvSpPr>
          <p:nvPr/>
        </p:nvSpPr>
        <p:spPr bwMode="auto">
          <a:xfrm rot="19102524">
            <a:off x="2702499" y="2149627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JNJ-BJ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 Box 26"/>
          <p:cNvSpPr txBox="1">
            <a:spLocks noChangeArrowheads="1"/>
          </p:cNvSpPr>
          <p:nvPr/>
        </p:nvSpPr>
        <p:spPr bwMode="auto">
          <a:xfrm>
            <a:off x="1018874" y="249124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Wnt3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Straight Connector 97"/>
          <p:cNvCxnSpPr/>
          <p:nvPr/>
        </p:nvCxnSpPr>
        <p:spPr>
          <a:xfrm>
            <a:off x="926206" y="2491096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 Box 51"/>
          <p:cNvSpPr txBox="1">
            <a:spLocks noChangeArrowheads="1"/>
          </p:cNvSpPr>
          <p:nvPr/>
        </p:nvSpPr>
        <p:spPr bwMode="auto">
          <a:xfrm rot="16200000">
            <a:off x="-505598" y="8395131"/>
            <a:ext cx="17107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vasion 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fold change against average)</a:t>
            </a:r>
          </a:p>
        </p:txBody>
      </p:sp>
      <p:sp>
        <p:nvSpPr>
          <p:cNvPr id="102" name="Text Box 26"/>
          <p:cNvSpPr txBox="1">
            <a:spLocks noChangeArrowheads="1"/>
          </p:cNvSpPr>
          <p:nvPr/>
        </p:nvSpPr>
        <p:spPr bwMode="auto">
          <a:xfrm>
            <a:off x="-62040" y="9537064"/>
            <a:ext cx="91336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nt3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 Box 26"/>
          <p:cNvSpPr txBox="1">
            <a:spLocks noChangeArrowheads="1"/>
          </p:cNvSpPr>
          <p:nvPr/>
        </p:nvSpPr>
        <p:spPr bwMode="auto">
          <a:xfrm>
            <a:off x="1288540" y="929640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 Box 26"/>
          <p:cNvSpPr txBox="1">
            <a:spLocks noChangeArrowheads="1"/>
          </p:cNvSpPr>
          <p:nvPr/>
        </p:nvSpPr>
        <p:spPr bwMode="auto">
          <a:xfrm>
            <a:off x="1861672" y="929640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 Box 26"/>
          <p:cNvSpPr txBox="1">
            <a:spLocks noChangeArrowheads="1"/>
          </p:cNvSpPr>
          <p:nvPr/>
        </p:nvSpPr>
        <p:spPr bwMode="auto">
          <a:xfrm>
            <a:off x="1611553" y="37876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322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 Box 26"/>
          <p:cNvSpPr txBox="1">
            <a:spLocks noChangeArrowheads="1"/>
          </p:cNvSpPr>
          <p:nvPr/>
        </p:nvSpPr>
        <p:spPr bwMode="auto">
          <a:xfrm>
            <a:off x="60880" y="937260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GF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 Box 26"/>
          <p:cNvSpPr txBox="1">
            <a:spLocks noChangeArrowheads="1"/>
          </p:cNvSpPr>
          <p:nvPr/>
        </p:nvSpPr>
        <p:spPr bwMode="auto">
          <a:xfrm>
            <a:off x="704850" y="929640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 Box 26"/>
          <p:cNvSpPr txBox="1">
            <a:spLocks noChangeArrowheads="1"/>
          </p:cNvSpPr>
          <p:nvPr/>
        </p:nvSpPr>
        <p:spPr bwMode="auto">
          <a:xfrm>
            <a:off x="704850" y="953229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 Box 26"/>
          <p:cNvSpPr txBox="1">
            <a:spLocks noChangeArrowheads="1"/>
          </p:cNvSpPr>
          <p:nvPr/>
        </p:nvSpPr>
        <p:spPr bwMode="auto">
          <a:xfrm>
            <a:off x="1288540" y="953229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 Box 26"/>
          <p:cNvSpPr txBox="1">
            <a:spLocks noChangeArrowheads="1"/>
          </p:cNvSpPr>
          <p:nvPr/>
        </p:nvSpPr>
        <p:spPr bwMode="auto">
          <a:xfrm>
            <a:off x="1861672" y="953229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 Box 26"/>
          <p:cNvSpPr txBox="1">
            <a:spLocks noChangeArrowheads="1"/>
          </p:cNvSpPr>
          <p:nvPr/>
        </p:nvSpPr>
        <p:spPr bwMode="auto">
          <a:xfrm>
            <a:off x="1232934" y="786880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477515" y="9481294"/>
            <a:ext cx="23791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8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1" name="Chart 10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1394977"/>
              </p:ext>
            </p:extLst>
          </p:nvPr>
        </p:nvGraphicFramePr>
        <p:xfrm>
          <a:off x="497796" y="632520"/>
          <a:ext cx="2850719" cy="1473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9" name="Chart 1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8424127"/>
              </p:ext>
            </p:extLst>
          </p:nvPr>
        </p:nvGraphicFramePr>
        <p:xfrm>
          <a:off x="3642110" y="5687422"/>
          <a:ext cx="2937240" cy="1639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22" name="CasellaDiTesto 66"/>
          <p:cNvSpPr txBox="1"/>
          <p:nvPr/>
        </p:nvSpPr>
        <p:spPr>
          <a:xfrm>
            <a:off x="792755" y="4836044"/>
            <a:ext cx="668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DMSO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CasellaDiTesto 66"/>
          <p:cNvSpPr txBox="1"/>
          <p:nvPr/>
        </p:nvSpPr>
        <p:spPr>
          <a:xfrm>
            <a:off x="1646522" y="4836044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XAV939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CasellaDiTesto 66"/>
          <p:cNvSpPr txBox="1"/>
          <p:nvPr/>
        </p:nvSpPr>
        <p:spPr>
          <a:xfrm>
            <a:off x="2498997" y="4836044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JNJ-BJ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799843" y="5066876"/>
            <a:ext cx="21945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CasellaDiTesto 66"/>
          <p:cNvSpPr txBox="1"/>
          <p:nvPr/>
        </p:nvSpPr>
        <p:spPr>
          <a:xfrm>
            <a:off x="1620365" y="5066876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Wnt3a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CasellaDiTesto 66"/>
          <p:cNvSpPr txBox="1"/>
          <p:nvPr/>
        </p:nvSpPr>
        <p:spPr>
          <a:xfrm>
            <a:off x="4104075" y="4836044"/>
            <a:ext cx="668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DMSO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CasellaDiTesto 66"/>
          <p:cNvSpPr txBox="1"/>
          <p:nvPr/>
        </p:nvSpPr>
        <p:spPr>
          <a:xfrm>
            <a:off x="4957842" y="4836044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XAV939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CasellaDiTesto 66"/>
          <p:cNvSpPr txBox="1"/>
          <p:nvPr/>
        </p:nvSpPr>
        <p:spPr>
          <a:xfrm>
            <a:off x="5810317" y="4836044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JNJ-BJ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>
            <a:off x="4111163" y="5066876"/>
            <a:ext cx="21945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CasellaDiTesto 66"/>
          <p:cNvSpPr txBox="1"/>
          <p:nvPr/>
        </p:nvSpPr>
        <p:spPr>
          <a:xfrm>
            <a:off x="4931685" y="5066876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Wnt3a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CasellaDiTesto 66"/>
          <p:cNvSpPr txBox="1"/>
          <p:nvPr/>
        </p:nvSpPr>
        <p:spPr>
          <a:xfrm>
            <a:off x="847102" y="7150349"/>
            <a:ext cx="668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DMSO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CasellaDiTesto 66"/>
          <p:cNvSpPr txBox="1"/>
          <p:nvPr/>
        </p:nvSpPr>
        <p:spPr>
          <a:xfrm>
            <a:off x="1700869" y="7150349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XAV939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CasellaDiTesto 66"/>
          <p:cNvSpPr txBox="1"/>
          <p:nvPr/>
        </p:nvSpPr>
        <p:spPr>
          <a:xfrm>
            <a:off x="2553344" y="7150349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JNJ-BJ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Straight Connector 133"/>
          <p:cNvCxnSpPr/>
          <p:nvPr/>
        </p:nvCxnSpPr>
        <p:spPr>
          <a:xfrm>
            <a:off x="854190" y="7381181"/>
            <a:ext cx="21945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CasellaDiTesto 66"/>
          <p:cNvSpPr txBox="1"/>
          <p:nvPr/>
        </p:nvSpPr>
        <p:spPr>
          <a:xfrm>
            <a:off x="1674712" y="7390175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Wnt3a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CasellaDiTesto 66"/>
          <p:cNvSpPr txBox="1"/>
          <p:nvPr/>
        </p:nvSpPr>
        <p:spPr>
          <a:xfrm>
            <a:off x="4059070" y="7152438"/>
            <a:ext cx="668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DMSO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CasellaDiTesto 66"/>
          <p:cNvSpPr txBox="1"/>
          <p:nvPr/>
        </p:nvSpPr>
        <p:spPr>
          <a:xfrm>
            <a:off x="4912837" y="7152438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XAV939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CasellaDiTesto 66"/>
          <p:cNvSpPr txBox="1"/>
          <p:nvPr/>
        </p:nvSpPr>
        <p:spPr>
          <a:xfrm>
            <a:off x="5765312" y="7152438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JNJ-BJ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Straight Connector 138"/>
          <p:cNvCxnSpPr/>
          <p:nvPr/>
        </p:nvCxnSpPr>
        <p:spPr>
          <a:xfrm>
            <a:off x="4066158" y="7383270"/>
            <a:ext cx="21945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CasellaDiTesto 66"/>
          <p:cNvSpPr txBox="1"/>
          <p:nvPr/>
        </p:nvSpPr>
        <p:spPr>
          <a:xfrm>
            <a:off x="4886680" y="7392264"/>
            <a:ext cx="631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Wnt3a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Diamond 146"/>
          <p:cNvSpPr/>
          <p:nvPr/>
        </p:nvSpPr>
        <p:spPr bwMode="auto">
          <a:xfrm>
            <a:off x="1697683" y="3072149"/>
            <a:ext cx="91440" cy="91440"/>
          </a:xfrm>
          <a:prstGeom prst="diamond">
            <a:avLst/>
          </a:prstGeom>
          <a:solidFill>
            <a:schemeClr val="tx1">
              <a:lumMod val="85000"/>
              <a:lumOff val="15000"/>
            </a:schemeClr>
          </a:solidFill>
          <a:ln w="9525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it-IT" sz="1100"/>
          </a:p>
        </p:txBody>
      </p:sp>
      <p:sp>
        <p:nvSpPr>
          <p:cNvPr id="148" name="Diamond 147"/>
          <p:cNvSpPr/>
          <p:nvPr/>
        </p:nvSpPr>
        <p:spPr bwMode="auto">
          <a:xfrm>
            <a:off x="2352279" y="3072149"/>
            <a:ext cx="91440" cy="89073"/>
          </a:xfrm>
          <a:prstGeom prst="diamond">
            <a:avLst/>
          </a:prstGeom>
          <a:solidFill>
            <a:srgbClr val="FF0000"/>
          </a:solidFill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it-IT" sz="1100"/>
          </a:p>
        </p:txBody>
      </p:sp>
      <p:sp>
        <p:nvSpPr>
          <p:cNvPr id="149" name="Diamond 148"/>
          <p:cNvSpPr/>
          <p:nvPr/>
        </p:nvSpPr>
        <p:spPr bwMode="auto">
          <a:xfrm>
            <a:off x="3006875" y="3072149"/>
            <a:ext cx="91440" cy="89073"/>
          </a:xfrm>
          <a:prstGeom prst="diamond">
            <a:avLst/>
          </a:prstGeom>
          <a:solidFill>
            <a:srgbClr val="00B050"/>
          </a:solidFill>
          <a:ln w="952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it-IT" sz="1100"/>
          </a:p>
        </p:txBody>
      </p:sp>
      <p:sp>
        <p:nvSpPr>
          <p:cNvPr id="150" name="Diamond 149"/>
          <p:cNvSpPr/>
          <p:nvPr/>
        </p:nvSpPr>
        <p:spPr bwMode="auto">
          <a:xfrm>
            <a:off x="3661472" y="3072149"/>
            <a:ext cx="91440" cy="91440"/>
          </a:xfrm>
          <a:prstGeom prst="diamond">
            <a:avLst/>
          </a:prstGeom>
          <a:solidFill>
            <a:schemeClr val="accent6">
              <a:lumMod val="75000"/>
            </a:schemeClr>
          </a:solidFill>
          <a:ln w="9525" cap="flat" cmpd="sng" algn="ctr">
            <a:solidFill>
              <a:schemeClr val="accent6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it-IT" sz="1100"/>
          </a:p>
        </p:txBody>
      </p:sp>
      <p:sp>
        <p:nvSpPr>
          <p:cNvPr id="151" name="Diamond 150"/>
          <p:cNvSpPr/>
          <p:nvPr/>
        </p:nvSpPr>
        <p:spPr bwMode="auto">
          <a:xfrm>
            <a:off x="4316069" y="3072149"/>
            <a:ext cx="91440" cy="91440"/>
          </a:xfrm>
          <a:prstGeom prst="diamond">
            <a:avLst/>
          </a:prstGeom>
          <a:solidFill>
            <a:schemeClr val="tx2">
              <a:lumMod val="60000"/>
              <a:lumOff val="40000"/>
            </a:schemeClr>
          </a:solidFill>
          <a:ln w="9525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it-IT" sz="1100"/>
          </a:p>
        </p:txBody>
      </p:sp>
      <p:sp>
        <p:nvSpPr>
          <p:cNvPr id="72" name="Text Box 26"/>
          <p:cNvSpPr txBox="1">
            <a:spLocks noChangeArrowheads="1"/>
          </p:cNvSpPr>
          <p:nvPr/>
        </p:nvSpPr>
        <p:spPr bwMode="auto">
          <a:xfrm>
            <a:off x="1299251" y="8830674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 Box 26"/>
          <p:cNvSpPr txBox="1">
            <a:spLocks noChangeArrowheads="1"/>
          </p:cNvSpPr>
          <p:nvPr/>
        </p:nvSpPr>
        <p:spPr bwMode="auto">
          <a:xfrm>
            <a:off x="1887841" y="8053425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1814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4194085" y="9481294"/>
            <a:ext cx="2464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le 8</a:t>
            </a:r>
            <a:r>
              <a:rPr lang="it-IT" sz="1000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03676" y="632520"/>
            <a:ext cx="5850650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: Figure S3. </a:t>
            </a:r>
            <a:r>
              <a:rPr lang="en-US" sz="1000" b="1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tenin/TCF-dependent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adouts are not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stantially influence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y TNKS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activation</a:t>
            </a:r>
          </a:p>
          <a:p>
            <a:pPr algn="just"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OPflas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ssay measuring basal and Wnt3a-induced </a:t>
            </a:r>
            <a:r>
              <a:rPr lang="en-US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atenin transcriptional activity in untreated or TNKS-inhibited cells. H322 cells were transfected with either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OPflas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r the contro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OPflas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porter plasmids (Day 0). 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he medium was renewed with fresh medium supplemented with either DMSO or TNKS inhibitors (10 </a:t>
            </a:r>
            <a:r>
              <a:rPr lang="en-US" sz="10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y 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Wnt3a (2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l) was added where appropriate. On Day 3, luciferase activity was assessed as described in Materials and Methods. Data are presented as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verage (lines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ang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wo independent experiment (diamonds), each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erformed 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chnical triplicate or quadruplicate;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readout is the ratio between TOPflash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OPflas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porter signals. Ratio = 1 indicates lack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atenin specific activation. B, RT-q-PCR analysis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indicate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targe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es in H322, HCC827, A549, and H460 cells, with or without TNKS inhibitors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lowing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nt3a stimulation for 24 h. Cells were pre-incubated with DMSO or TNKS inhibitors (10 </a:t>
            </a:r>
            <a:r>
              <a:rPr lang="en-US" sz="10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for 24 h, and then Wnt3a (2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l) was added for another 24 h before cel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ysi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Results are the average (lines) ± range of two independen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 (diamonds)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ach performed in technica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iplicate. C, Analys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CC827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 invasion through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reconstitut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asement membranes using the follow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emoattractant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for 24 h: unconditioned FBS-deprived medium; medium supplemented with 2% FBS and Wnt3a (200 ng/ml); HGF-containing medium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g/ml)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re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an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lines) ±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M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re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dependent experiments (diamonds)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ach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erformed in technica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uplicat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&lt; 0.001 by two-tailed Student’s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test (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GF-treat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ersus untreated). NS, not significant. Raw data are shown in Additional File 9.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6501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186</TotalTime>
  <Words>457</Words>
  <Application>Microsoft Office PowerPoint</Application>
  <PresentationFormat>A4 Paper (210x297 mm)</PresentationFormat>
  <Paragraphs>66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35</cp:revision>
  <cp:lastPrinted>2014-11-21T15:42:42Z</cp:lastPrinted>
  <dcterms:created xsi:type="dcterms:W3CDTF">2006-08-16T00:00:00Z</dcterms:created>
  <dcterms:modified xsi:type="dcterms:W3CDTF">2015-12-14T09:37:39Z</dcterms:modified>
</cp:coreProperties>
</file>